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8" r:id="rId2"/>
    <p:sldId id="259" r:id="rId3"/>
    <p:sldId id="264" r:id="rId4"/>
    <p:sldId id="256" r:id="rId5"/>
    <p:sldId id="263" r:id="rId6"/>
  </p:sldIdLst>
  <p:sldSz cx="7772400" cy="10058400"/>
  <p:notesSz cx="7315200" cy="9601200"/>
  <p:defaultTextStyle>
    <a:defPPr>
      <a:defRPr lang="en-US"/>
    </a:defPPr>
    <a:lvl1pPr marL="0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CC0099"/>
    <a:srgbClr val="3399FF"/>
    <a:srgbClr val="00FF00"/>
    <a:srgbClr val="00FFFF"/>
    <a:srgbClr val="EEE3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6283" autoAdjust="0"/>
  </p:normalViewPr>
  <p:slideViewPr>
    <p:cSldViewPr>
      <p:cViewPr>
        <p:scale>
          <a:sx n="66" d="100"/>
          <a:sy n="66" d="100"/>
        </p:scale>
        <p:origin x="2888" y="176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9E70F403-F3C4-4405-8602-B74AAF91F172}" type="datetimeFigureOut">
              <a:rPr lang="en-US" smtClean="0"/>
              <a:t>4/6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6950" y="720725"/>
            <a:ext cx="27813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7E801947-41C5-4511-8714-DDF6CD1837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776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1pPr>
    <a:lvl2pPr marL="254706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2pPr>
    <a:lvl3pPr marL="509412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3pPr>
    <a:lvl4pPr marL="764118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4pPr>
    <a:lvl5pPr marL="1018824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5pPr>
    <a:lvl6pPr marL="1273531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6pPr>
    <a:lvl7pPr marL="1528237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7pPr>
    <a:lvl8pPr marL="1782943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8pPr>
    <a:lvl9pPr marL="2037649" algn="l" defTabSz="509412" rtl="0" eaLnBrk="1" latinLnBrk="0" hangingPunct="1">
      <a:defRPr sz="6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6950" y="720725"/>
            <a:ext cx="2781300" cy="36004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801947-41C5-4511-8714-DDF6CD18378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7789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6950" y="720725"/>
            <a:ext cx="2781300" cy="36004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66612">
              <a:defRPr/>
            </a:pPr>
            <a:endParaRPr lang="en-US" sz="13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801947-41C5-4511-8714-DDF6CD18378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3925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6950" y="720725"/>
            <a:ext cx="2781300" cy="36004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801947-41C5-4511-8714-DDF6CD18378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25155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6950" y="720725"/>
            <a:ext cx="2781300" cy="36004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801947-41C5-4511-8714-DDF6CD18378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41002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6950" y="720725"/>
            <a:ext cx="2781300" cy="36004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801947-41C5-4511-8714-DDF6CD18378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5945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29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058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08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116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14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17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20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23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3"/>
            <a:ext cx="1748790" cy="85822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3"/>
            <a:ext cx="5116830" cy="85822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4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1pPr>
            <a:lvl2pPr marL="50292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1"/>
            <a:ext cx="3432810" cy="6638079"/>
          </a:xfrm>
        </p:spPr>
        <p:txBody>
          <a:bodyPr/>
          <a:lstStyle>
            <a:lvl1pPr>
              <a:defRPr sz="3080"/>
            </a:lvl1pPr>
            <a:lvl2pPr>
              <a:defRPr sz="2640"/>
            </a:lvl2pPr>
            <a:lvl3pPr>
              <a:defRPr sz="2200"/>
            </a:lvl3pPr>
            <a:lvl4pPr>
              <a:defRPr sz="1980"/>
            </a:lvl4pPr>
            <a:lvl5pPr>
              <a:defRPr sz="1980"/>
            </a:lvl5pPr>
            <a:lvl6pPr>
              <a:defRPr sz="1980"/>
            </a:lvl6pPr>
            <a:lvl7pPr>
              <a:defRPr sz="1980"/>
            </a:lvl7pPr>
            <a:lvl8pPr>
              <a:defRPr sz="1980"/>
            </a:lvl8pPr>
            <a:lvl9pPr>
              <a:defRPr sz="19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1"/>
            <a:ext cx="3432810" cy="6638079"/>
          </a:xfrm>
        </p:spPr>
        <p:txBody>
          <a:bodyPr/>
          <a:lstStyle>
            <a:lvl1pPr>
              <a:defRPr sz="3080"/>
            </a:lvl1pPr>
            <a:lvl2pPr>
              <a:defRPr sz="2640"/>
            </a:lvl2pPr>
            <a:lvl3pPr>
              <a:defRPr sz="2200"/>
            </a:lvl3pPr>
            <a:lvl4pPr>
              <a:defRPr sz="1980"/>
            </a:lvl4pPr>
            <a:lvl5pPr>
              <a:defRPr sz="1980"/>
            </a:lvl5pPr>
            <a:lvl6pPr>
              <a:defRPr sz="1980"/>
            </a:lvl6pPr>
            <a:lvl7pPr>
              <a:defRPr sz="1980"/>
            </a:lvl7pPr>
            <a:lvl8pPr>
              <a:defRPr sz="1980"/>
            </a:lvl8pPr>
            <a:lvl9pPr>
              <a:defRPr sz="198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640"/>
            </a:lvl1pPr>
            <a:lvl2pPr>
              <a:defRPr sz="2200"/>
            </a:lvl2pPr>
            <a:lvl3pPr>
              <a:defRPr sz="1980"/>
            </a:lvl3pPr>
            <a:lvl4pPr>
              <a:defRPr sz="1760"/>
            </a:lvl4pPr>
            <a:lvl5pPr>
              <a:defRPr sz="1760"/>
            </a:lvl5pPr>
            <a:lvl6pPr>
              <a:defRPr sz="1760"/>
            </a:lvl6pPr>
            <a:lvl7pPr>
              <a:defRPr sz="1760"/>
            </a:lvl7pPr>
            <a:lvl8pPr>
              <a:defRPr sz="1760"/>
            </a:lvl8pPr>
            <a:lvl9pPr>
              <a:defRPr sz="17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640"/>
            </a:lvl1pPr>
            <a:lvl2pPr>
              <a:defRPr sz="2200"/>
            </a:lvl2pPr>
            <a:lvl3pPr>
              <a:defRPr sz="1980"/>
            </a:lvl3pPr>
            <a:lvl4pPr>
              <a:defRPr sz="1760"/>
            </a:lvl4pPr>
            <a:lvl5pPr>
              <a:defRPr sz="1760"/>
            </a:lvl5pPr>
            <a:lvl6pPr>
              <a:defRPr sz="1760"/>
            </a:lvl6pPr>
            <a:lvl7pPr>
              <a:defRPr sz="1760"/>
            </a:lvl7pPr>
            <a:lvl8pPr>
              <a:defRPr sz="1760"/>
            </a:lvl8pPr>
            <a:lvl9pPr>
              <a:defRPr sz="17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1" y="400473"/>
            <a:ext cx="2557066" cy="1704340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3" y="400474"/>
            <a:ext cx="4344988" cy="8584566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1" y="2104814"/>
            <a:ext cx="2557066" cy="6880226"/>
          </a:xfrm>
        </p:spPr>
        <p:txBody>
          <a:bodyPr/>
          <a:lstStyle>
            <a:lvl1pPr marL="0" indent="0">
              <a:buNone/>
              <a:defRPr sz="1540"/>
            </a:lvl1pPr>
            <a:lvl2pPr marL="502920" indent="0">
              <a:buNone/>
              <a:defRPr sz="1320"/>
            </a:lvl2pPr>
            <a:lvl3pPr marL="1005840" indent="0">
              <a:buNone/>
              <a:defRPr sz="1100"/>
            </a:lvl3pPr>
            <a:lvl4pPr marL="1508760" indent="0">
              <a:buNone/>
              <a:defRPr sz="990"/>
            </a:lvl4pPr>
            <a:lvl5pPr marL="2011680" indent="0">
              <a:buNone/>
              <a:defRPr sz="990"/>
            </a:lvl5pPr>
            <a:lvl6pPr marL="2514600" indent="0">
              <a:buNone/>
              <a:defRPr sz="990"/>
            </a:lvl6pPr>
            <a:lvl7pPr marL="3017520" indent="0">
              <a:buNone/>
              <a:defRPr sz="990"/>
            </a:lvl7pPr>
            <a:lvl8pPr marL="3520440" indent="0">
              <a:buNone/>
              <a:defRPr sz="990"/>
            </a:lvl8pPr>
            <a:lvl9pPr marL="4023360" indent="0">
              <a:buNone/>
              <a:defRPr sz="99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2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540"/>
            </a:lvl1pPr>
            <a:lvl2pPr marL="502920" indent="0">
              <a:buNone/>
              <a:defRPr sz="1320"/>
            </a:lvl2pPr>
            <a:lvl3pPr marL="1005840" indent="0">
              <a:buNone/>
              <a:defRPr sz="1100"/>
            </a:lvl3pPr>
            <a:lvl4pPr marL="1508760" indent="0">
              <a:buNone/>
              <a:defRPr sz="990"/>
            </a:lvl4pPr>
            <a:lvl5pPr marL="2011680" indent="0">
              <a:buNone/>
              <a:defRPr sz="990"/>
            </a:lvl5pPr>
            <a:lvl6pPr marL="2514600" indent="0">
              <a:buNone/>
              <a:defRPr sz="990"/>
            </a:lvl6pPr>
            <a:lvl7pPr marL="3017520" indent="0">
              <a:buNone/>
              <a:defRPr sz="990"/>
            </a:lvl7pPr>
            <a:lvl8pPr marL="3520440" indent="0">
              <a:buNone/>
              <a:defRPr sz="990"/>
            </a:lvl8pPr>
            <a:lvl9pPr marL="4023360" indent="0">
              <a:buNone/>
              <a:defRPr sz="99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182880" tIns="91440" rIns="182880" bIns="9144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182880" tIns="91440" rIns="182880" bIns="9144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8"/>
            <a:ext cx="1813560" cy="535517"/>
          </a:xfrm>
          <a:prstGeom prst="rect">
            <a:avLst/>
          </a:prstGeom>
        </p:spPr>
        <p:txBody>
          <a:bodyPr vert="horz" lIns="182880" tIns="91440" rIns="182880" bIns="9144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8"/>
            <a:ext cx="2461260" cy="535517"/>
          </a:xfrm>
          <a:prstGeom prst="rect">
            <a:avLst/>
          </a:prstGeom>
        </p:spPr>
        <p:txBody>
          <a:bodyPr vert="horz" lIns="182880" tIns="91440" rIns="182880" bIns="9144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8"/>
            <a:ext cx="1813560" cy="535517"/>
          </a:xfrm>
          <a:prstGeom prst="rect">
            <a:avLst/>
          </a:prstGeom>
        </p:spPr>
        <p:txBody>
          <a:bodyPr vert="horz" lIns="182880" tIns="91440" rIns="182880" bIns="9144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05840" rtl="0" eaLnBrk="1" latinLnBrk="0" hangingPunct="1"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190" indent="-377190" algn="l" defTabSz="1005840" rtl="0" eaLnBrk="1" latinLnBrk="0" hangingPunct="1">
        <a:spcBef>
          <a:spcPct val="20000"/>
        </a:spcBef>
        <a:buFont typeface="Arial" pitchFamily="34" charset="0"/>
        <a:buChar char="•"/>
        <a:defRPr sz="3520" kern="1200">
          <a:solidFill>
            <a:schemeClr val="tx1"/>
          </a:solidFill>
          <a:latin typeface="+mn-lt"/>
          <a:ea typeface="+mn-ea"/>
          <a:cs typeface="+mn-cs"/>
        </a:defRPr>
      </a:lvl1pPr>
      <a:lvl2pPr marL="817245" indent="-314325" algn="l" defTabSz="1005840" rtl="0" eaLnBrk="1" latinLnBrk="0" hangingPunct="1">
        <a:spcBef>
          <a:spcPct val="20000"/>
        </a:spcBef>
        <a:buFont typeface="Arial" pitchFamily="34" charset="0"/>
        <a:buChar char="–"/>
        <a:defRPr sz="308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spcBef>
          <a:spcPct val="20000"/>
        </a:spcBef>
        <a:buFont typeface="Arial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spcBef>
          <a:spcPct val="20000"/>
        </a:spcBef>
        <a:buFont typeface="Arial" pitchFamily="34" charset="0"/>
        <a:buChar char="»"/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0.png"/><Relationship Id="rId12" Type="http://schemas.openxmlformats.org/officeDocument/2006/relationships/image" Target="../media/image21.png"/><Relationship Id="rId13" Type="http://schemas.openxmlformats.org/officeDocument/2006/relationships/image" Target="../media/image22.png"/><Relationship Id="rId14" Type="http://schemas.openxmlformats.org/officeDocument/2006/relationships/image" Target="../media/image23.png"/><Relationship Id="rId15" Type="http://schemas.openxmlformats.org/officeDocument/2006/relationships/image" Target="../media/image24.png"/><Relationship Id="rId16" Type="http://schemas.openxmlformats.org/officeDocument/2006/relationships/image" Target="../media/image25.jpeg"/><Relationship Id="rId17" Type="http://schemas.openxmlformats.org/officeDocument/2006/relationships/image" Target="../media/image26.jpeg"/><Relationship Id="rId18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8" Type="http://schemas.openxmlformats.org/officeDocument/2006/relationships/image" Target="../media/image17.png"/><Relationship Id="rId9" Type="http://schemas.openxmlformats.org/officeDocument/2006/relationships/image" Target="../media/image18.png"/><Relationship Id="rId10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0030" y="214836"/>
            <a:ext cx="3604261" cy="2701606"/>
            <a:chOff x="228600" y="4482"/>
            <a:chExt cx="6553201" cy="4912011"/>
          </a:xfrm>
        </p:grpSpPr>
        <p:pic>
          <p:nvPicPr>
            <p:cNvPr id="9" name="Picture 8" descr="C:\Dropbox\UPENN - Mobile DB\Publications\2015-06-01_WORMEETING_FAT\Figure Development\20150622_130733.jpg"/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30" r="20737" b="18131"/>
            <a:stretch/>
          </p:blipFill>
          <p:spPr bwMode="auto">
            <a:xfrm>
              <a:off x="228600" y="4482"/>
              <a:ext cx="6553201" cy="49120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380824" y="4482"/>
              <a:ext cx="1816276" cy="99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97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484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40031" y="3036570"/>
            <a:ext cx="3604260" cy="3059430"/>
            <a:chOff x="228601" y="5262282"/>
            <a:chExt cx="6553200" cy="5562600"/>
          </a:xfrm>
        </p:grpSpPr>
        <p:sp>
          <p:nvSpPr>
            <p:cNvPr id="16" name="Rectangle 15"/>
            <p:cNvSpPr/>
            <p:nvPr/>
          </p:nvSpPr>
          <p:spPr>
            <a:xfrm>
              <a:off x="228601" y="5262282"/>
              <a:ext cx="6553200" cy="55626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3"/>
            </a:p>
          </p:txBody>
        </p:sp>
        <p:pic>
          <p:nvPicPr>
            <p:cNvPr id="2053" name="Picture 5" descr="C:\Dropbox\UPENN - Mobile DB\Publications\2016-02-01_FAT\Fig 1 worm starved\rot_n2_day2wellfed_2014_worm01.png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79" t="5726" r="39246" b="31084"/>
            <a:stretch/>
          </p:blipFill>
          <p:spPr bwMode="auto">
            <a:xfrm>
              <a:off x="914401" y="6329082"/>
              <a:ext cx="2870200" cy="39243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4" name="Picture 6" descr="C:\Dropbox\UPENN - Mobile DB\Publications\2016-02-01_FAT\Fig 1 worm starved\rot_eat2_day2_2014_worm15.png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90" t="13853" r="23250" b="8192"/>
            <a:stretch/>
          </p:blipFill>
          <p:spPr bwMode="auto">
            <a:xfrm>
              <a:off x="3784601" y="6087782"/>
              <a:ext cx="2032000" cy="41656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4"/>
            <p:cNvSpPr/>
            <p:nvPr/>
          </p:nvSpPr>
          <p:spPr>
            <a:xfrm>
              <a:off x="762001" y="5948082"/>
              <a:ext cx="2514600" cy="88696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3"/>
            </a:p>
          </p:txBody>
        </p:sp>
        <p:sp>
          <p:nvSpPr>
            <p:cNvPr id="14" name="Rectangle 13"/>
            <p:cNvSpPr/>
            <p:nvPr/>
          </p:nvSpPr>
          <p:spPr>
            <a:xfrm rot="5400000">
              <a:off x="1368553" y="9848739"/>
              <a:ext cx="76200" cy="14538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3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370916" y="5542698"/>
              <a:ext cx="991531" cy="7834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648201" y="5542698"/>
              <a:ext cx="1507405" cy="7834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00" i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at-2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58514" y="5262282"/>
              <a:ext cx="1816276" cy="998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97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484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50136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:\Dropbox\UPENN - Mobile DB\Publications\2015-01-30_Fat\Fig 3 worm stain\131123_ORO_N2_worm22_color_stitch_segment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18" r="50000"/>
          <a:stretch/>
        </p:blipFill>
        <p:spPr bwMode="auto">
          <a:xfrm>
            <a:off x="2838898" y="494766"/>
            <a:ext cx="1614853" cy="45117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Dropbox\UPENN - Mobile DB\Publications\2015-01-30_Fat\Fig 3 worm stain\131123_ORO_N2_worm22_coolsnap_segment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16" r="35769"/>
          <a:stretch/>
        </p:blipFill>
        <p:spPr bwMode="auto">
          <a:xfrm>
            <a:off x="4963199" y="251460"/>
            <a:ext cx="1605241" cy="49983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5" descr="C:\Dropbox\UPENN - Mobile DB\Publications\2015-01-30_Fat\Fig 3 worm stain\131123_DF_N2_worm22_coolsnap_segment_crop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3" y="631083"/>
            <a:ext cx="1997904" cy="42391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624108" y="631082"/>
            <a:ext cx="998952" cy="549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97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23552" y="631082"/>
            <a:ext cx="961222" cy="549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97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816612" y="631082"/>
            <a:ext cx="961222" cy="549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97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Rectangle 8"/>
          <p:cNvSpPr/>
          <p:nvPr/>
        </p:nvSpPr>
        <p:spPr>
          <a:xfrm rot="5400000">
            <a:off x="1960016" y="4315054"/>
            <a:ext cx="41910" cy="7996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3"/>
          </a:p>
        </p:txBody>
      </p:sp>
    </p:spTree>
    <p:extLst>
      <p:ext uri="{BB962C8B-B14F-4D97-AF65-F5344CB8AC3E}">
        <p14:creationId xmlns:p14="http://schemas.microsoft.com/office/powerpoint/2010/main" val="20626036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6905611"/>
              </p:ext>
            </p:extLst>
          </p:nvPr>
        </p:nvGraphicFramePr>
        <p:xfrm>
          <a:off x="3019425" y="2624403"/>
          <a:ext cx="1435418" cy="77934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35418">
                  <a:extLst>
                    <a:ext uri="{9D8B030D-6E8A-4147-A177-3AD203B41FA5}">
                      <a16:colId xmlns="" xmlns:a16="http://schemas.microsoft.com/office/drawing/2014/main" val="589968527"/>
                    </a:ext>
                  </a:extLst>
                </a:gridCol>
              </a:tblGrid>
              <a:tr h="389674">
                <a:tc>
                  <a:txBody>
                    <a:bodyPr/>
                    <a:lstStyle/>
                    <a:p>
                      <a:pPr marL="0" marR="0" indent="0" algn="r" defTabSz="1828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type</a:t>
                      </a:r>
                    </a:p>
                  </a:txBody>
                  <a:tcPr marL="50292" marR="50292" marT="25146" marB="25146"/>
                </a:tc>
                <a:extLst>
                  <a:ext uri="{0D108BD9-81ED-4DB2-BD59-A6C34878D82A}">
                    <a16:rowId xmlns="" xmlns:a16="http://schemas.microsoft.com/office/drawing/2014/main" val="2528097258"/>
                  </a:ext>
                </a:extLst>
              </a:tr>
              <a:tr h="389674">
                <a:tc>
                  <a:txBody>
                    <a:bodyPr/>
                    <a:lstStyle/>
                    <a:p>
                      <a:pPr algn="r"/>
                      <a:r>
                        <a:rPr lang="en-US" sz="16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od</a:t>
                      </a:r>
                    </a:p>
                  </a:txBody>
                  <a:tcPr marL="50292" marR="50292" marT="25146" marB="25146"/>
                </a:tc>
                <a:extLst>
                  <a:ext uri="{0D108BD9-81ED-4DB2-BD59-A6C34878D82A}">
                    <a16:rowId xmlns="" xmlns:a16="http://schemas.microsoft.com/office/drawing/2014/main" val="2249225770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1522841"/>
              </p:ext>
            </p:extLst>
          </p:nvPr>
        </p:nvGraphicFramePr>
        <p:xfrm>
          <a:off x="4637913" y="2659761"/>
          <a:ext cx="3017520" cy="74066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03504">
                  <a:extLst>
                    <a:ext uri="{9D8B030D-6E8A-4147-A177-3AD203B41FA5}">
                      <a16:colId xmlns="" xmlns:a16="http://schemas.microsoft.com/office/drawing/2014/main" val="589968527"/>
                    </a:ext>
                  </a:extLst>
                </a:gridCol>
                <a:gridCol w="603504">
                  <a:extLst>
                    <a:ext uri="{9D8B030D-6E8A-4147-A177-3AD203B41FA5}">
                      <a16:colId xmlns="" xmlns:a16="http://schemas.microsoft.com/office/drawing/2014/main" val="2347001515"/>
                    </a:ext>
                  </a:extLst>
                </a:gridCol>
                <a:gridCol w="603504">
                  <a:extLst>
                    <a:ext uri="{9D8B030D-6E8A-4147-A177-3AD203B41FA5}">
                      <a16:colId xmlns="" xmlns:a16="http://schemas.microsoft.com/office/drawing/2014/main" val="126896076"/>
                    </a:ext>
                  </a:extLst>
                </a:gridCol>
                <a:gridCol w="603504">
                  <a:extLst>
                    <a:ext uri="{9D8B030D-6E8A-4147-A177-3AD203B41FA5}">
                      <a16:colId xmlns="" xmlns:a16="http://schemas.microsoft.com/office/drawing/2014/main" val="4183512577"/>
                    </a:ext>
                  </a:extLst>
                </a:gridCol>
                <a:gridCol w="603504">
                  <a:extLst>
                    <a:ext uri="{9D8B030D-6E8A-4147-A177-3AD203B41FA5}">
                      <a16:colId xmlns="" xmlns:a16="http://schemas.microsoft.com/office/drawing/2014/main" val="1073502557"/>
                    </a:ext>
                  </a:extLst>
                </a:gridCol>
              </a:tblGrid>
              <a:tr h="260856">
                <a:tc>
                  <a:txBody>
                    <a:bodyPr/>
                    <a:lstStyle/>
                    <a:p>
                      <a:pPr algn="ctr"/>
                      <a:r>
                        <a:rPr lang="en-US" sz="1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2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2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pa-8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f-2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f-7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2528097258"/>
                  </a:ext>
                </a:extLst>
              </a:tr>
              <a:tr h="395440">
                <a:tc>
                  <a:txBody>
                    <a:bodyPr/>
                    <a:lstStyle/>
                    <a:p>
                      <a:pPr algn="ctr"/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50292" marR="50292" marT="25146" marB="25146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210050278"/>
                  </a:ext>
                </a:extLst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200400" y="137391"/>
            <a:ext cx="785976" cy="472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71713" y="3540123"/>
            <a:ext cx="785976" cy="472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3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68" r="2786"/>
          <a:stretch/>
        </p:blipFill>
        <p:spPr>
          <a:xfrm>
            <a:off x="4202336" y="464413"/>
            <a:ext cx="3526677" cy="2144060"/>
          </a:xfrm>
          <a:prstGeom prst="rect">
            <a:avLst/>
          </a:prstGeom>
        </p:spPr>
      </p:pic>
      <p:sp>
        <p:nvSpPr>
          <p:cNvPr id="77" name="TextBox 76"/>
          <p:cNvSpPr txBox="1"/>
          <p:nvPr/>
        </p:nvSpPr>
        <p:spPr>
          <a:xfrm rot="16200000">
            <a:off x="2985977" y="1123802"/>
            <a:ext cx="2011223" cy="36317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1472550"/>
            <a:r>
              <a:rPr lang="en-US" sz="176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density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4483608" y="514626"/>
            <a:ext cx="1399360" cy="544400"/>
            <a:chOff x="9727906" y="283738"/>
            <a:chExt cx="1509505" cy="1258031"/>
          </a:xfrm>
        </p:grpSpPr>
        <p:sp>
          <p:nvSpPr>
            <p:cNvPr id="78" name="Oval 77"/>
            <p:cNvSpPr/>
            <p:nvPr/>
          </p:nvSpPr>
          <p:spPr>
            <a:xfrm>
              <a:off x="11066674" y="467613"/>
              <a:ext cx="170737" cy="365760"/>
            </a:xfrm>
            <a:prstGeom prst="ellipse">
              <a:avLst/>
            </a:prstGeom>
            <a:solidFill>
              <a:srgbClr val="0072BD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72550">
                <a:defRPr/>
              </a:pPr>
              <a:endParaRPr lang="en-US" sz="1400" kern="0" dirty="0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82" name="Oval 81"/>
            <p:cNvSpPr/>
            <p:nvPr/>
          </p:nvSpPr>
          <p:spPr>
            <a:xfrm>
              <a:off x="11066673" y="998754"/>
              <a:ext cx="170737" cy="365760"/>
            </a:xfrm>
            <a:prstGeom prst="ellipse">
              <a:avLst/>
            </a:prstGeom>
            <a:solidFill>
              <a:srgbClr val="D95319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1472550">
                <a:defRPr/>
              </a:pPr>
              <a:endParaRPr lang="en-US" sz="1400" kern="0" dirty="0">
                <a:solidFill>
                  <a:prstClr val="white"/>
                </a:solidFill>
                <a:latin typeface="Calibri" panose="020F0502020204030204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9727906" y="283738"/>
              <a:ext cx="1282094" cy="71122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 defTabSz="1472550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rk field 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0210648" y="830540"/>
              <a:ext cx="793847" cy="71122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r" defTabSz="1472550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O </a:t>
              </a:r>
            </a:p>
          </p:txBody>
        </p:sp>
      </p:grpSp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00" r="4489"/>
          <a:stretch/>
        </p:blipFill>
        <p:spPr>
          <a:xfrm>
            <a:off x="973829" y="4091641"/>
            <a:ext cx="5669932" cy="436655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667713" y="5813612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031833" y="5286390"/>
            <a:ext cx="308700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340382" y="6132723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19" name="Straight Connector 18"/>
          <p:cNvCxnSpPr>
            <a:cxnSpLocks/>
          </p:cNvCxnSpPr>
          <p:nvPr/>
        </p:nvCxnSpPr>
        <p:spPr>
          <a:xfrm flipH="1" flipV="1">
            <a:off x="3399391" y="6052332"/>
            <a:ext cx="136959" cy="28413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258545" y="5828570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543058" y="5917162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612847" y="7328708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214185" y="7373004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038477" y="6647780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587354" y="7113147"/>
            <a:ext cx="1328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cxnSp>
        <p:nvCxnSpPr>
          <p:cNvPr id="44" name="Straight Connector 43"/>
          <p:cNvCxnSpPr>
            <a:cxnSpLocks/>
          </p:cNvCxnSpPr>
          <p:nvPr/>
        </p:nvCxnSpPr>
        <p:spPr>
          <a:xfrm flipH="1" flipV="1">
            <a:off x="2529255" y="6048274"/>
            <a:ext cx="349962" cy="3508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249446" y="5805438"/>
            <a:ext cx="454790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452570" y="6467682"/>
            <a:ext cx="35319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grpSp>
        <p:nvGrpSpPr>
          <p:cNvPr id="49" name="Group 48"/>
          <p:cNvGrpSpPr/>
          <p:nvPr/>
        </p:nvGrpSpPr>
        <p:grpSpPr>
          <a:xfrm>
            <a:off x="3986596" y="6544661"/>
            <a:ext cx="841812" cy="467925"/>
            <a:chOff x="8021307" y="14060880"/>
            <a:chExt cx="1530510" cy="908603"/>
          </a:xfrm>
        </p:grpSpPr>
        <p:cxnSp>
          <p:nvCxnSpPr>
            <p:cNvPr id="50" name="Straight Connector 49"/>
            <p:cNvCxnSpPr/>
            <p:nvPr/>
          </p:nvCxnSpPr>
          <p:spPr>
            <a:xfrm>
              <a:off x="8021307" y="14060880"/>
              <a:ext cx="871790" cy="67987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8781449" y="14569113"/>
              <a:ext cx="770368" cy="400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3" b="1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</p:grpSp>
      <p:cxnSp>
        <p:nvCxnSpPr>
          <p:cNvPr id="53" name="Straight Connector 52"/>
          <p:cNvCxnSpPr>
            <a:cxnSpLocks/>
          </p:cNvCxnSpPr>
          <p:nvPr/>
        </p:nvCxnSpPr>
        <p:spPr>
          <a:xfrm flipH="1" flipV="1">
            <a:off x="3055805" y="5852725"/>
            <a:ext cx="274251" cy="4016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2826006" y="5557928"/>
            <a:ext cx="492939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606943" y="6515356"/>
            <a:ext cx="41933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3866336" y="6750776"/>
            <a:ext cx="483560" cy="3905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4321774" y="7107229"/>
            <a:ext cx="372974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3135267" y="7246034"/>
            <a:ext cx="407791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1979838" y="7007216"/>
            <a:ext cx="38838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cxnSp>
        <p:nvCxnSpPr>
          <p:cNvPr id="71" name="Straight Connector 70"/>
          <p:cNvCxnSpPr>
            <a:cxnSpLocks/>
          </p:cNvCxnSpPr>
          <p:nvPr/>
        </p:nvCxnSpPr>
        <p:spPr>
          <a:xfrm>
            <a:off x="3532953" y="6642283"/>
            <a:ext cx="493694" cy="4708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3942457" y="7084727"/>
            <a:ext cx="397925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endParaRPr lang="en-US" sz="110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939131" y="4247544"/>
            <a:ext cx="552940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5869342" y="4139413"/>
            <a:ext cx="552940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6535118" y="4366810"/>
            <a:ext cx="552940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</p:txBody>
      </p:sp>
      <p:cxnSp>
        <p:nvCxnSpPr>
          <p:cNvPr id="87" name="Straight Connector 86"/>
          <p:cNvCxnSpPr/>
          <p:nvPr/>
        </p:nvCxnSpPr>
        <p:spPr>
          <a:xfrm>
            <a:off x="4186182" y="6544653"/>
            <a:ext cx="420760" cy="986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2915744" y="6868206"/>
            <a:ext cx="419337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US" sz="110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688534" y="5835953"/>
            <a:ext cx="400058" cy="206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3" b="1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US" sz="110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/>
          <p:cNvCxnSpPr>
            <a:cxnSpLocks/>
          </p:cNvCxnSpPr>
          <p:nvPr/>
        </p:nvCxnSpPr>
        <p:spPr>
          <a:xfrm flipH="1" flipV="1">
            <a:off x="2967966" y="6069238"/>
            <a:ext cx="281317" cy="2722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>
            <a:cxnSpLocks/>
          </p:cNvCxnSpPr>
          <p:nvPr/>
        </p:nvCxnSpPr>
        <p:spPr>
          <a:xfrm flipV="1">
            <a:off x="3172441" y="6830081"/>
            <a:ext cx="110286" cy="956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168891" y="183780"/>
            <a:ext cx="2835833" cy="3166942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3"/>
          </a:p>
        </p:txBody>
      </p:sp>
      <p:sp>
        <p:nvSpPr>
          <p:cNvPr id="56" name="TextBox 55"/>
          <p:cNvSpPr txBox="1"/>
          <p:nvPr/>
        </p:nvSpPr>
        <p:spPr>
          <a:xfrm>
            <a:off x="171713" y="177347"/>
            <a:ext cx="785976" cy="4322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97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84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69"/>
          <a:stretch/>
        </p:blipFill>
        <p:spPr>
          <a:xfrm>
            <a:off x="759010" y="567201"/>
            <a:ext cx="420376" cy="2783522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88"/>
          <a:stretch/>
        </p:blipFill>
        <p:spPr>
          <a:xfrm>
            <a:off x="1462096" y="598888"/>
            <a:ext cx="461590" cy="2673936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8089" y="826395"/>
            <a:ext cx="803661" cy="2423345"/>
          </a:xfrm>
          <a:prstGeom prst="rect">
            <a:avLst/>
          </a:prstGeom>
        </p:spPr>
      </p:pic>
      <p:sp>
        <p:nvSpPr>
          <p:cNvPr id="64" name="Rectangle 63"/>
          <p:cNvSpPr/>
          <p:nvPr/>
        </p:nvSpPr>
        <p:spPr>
          <a:xfrm rot="5400000">
            <a:off x="539362" y="2934544"/>
            <a:ext cx="54952" cy="6291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3"/>
          </a:p>
        </p:txBody>
      </p:sp>
      <p:sp>
        <p:nvSpPr>
          <p:cNvPr id="65" name="TextBox 64"/>
          <p:cNvSpPr txBox="1"/>
          <p:nvPr/>
        </p:nvSpPr>
        <p:spPr>
          <a:xfrm>
            <a:off x="685800" y="228600"/>
            <a:ext cx="429075" cy="3390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2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1267275" y="228600"/>
            <a:ext cx="652315" cy="3390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f-2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2181675" y="228600"/>
            <a:ext cx="652315" cy="3390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f-7</a:t>
            </a:r>
          </a:p>
        </p:txBody>
      </p:sp>
      <p:cxnSp>
        <p:nvCxnSpPr>
          <p:cNvPr id="69" name="Straight Connector 68"/>
          <p:cNvCxnSpPr>
            <a:cxnSpLocks/>
          </p:cNvCxnSpPr>
          <p:nvPr/>
        </p:nvCxnSpPr>
        <p:spPr>
          <a:xfrm flipH="1" flipV="1">
            <a:off x="4191000" y="5543375"/>
            <a:ext cx="141065" cy="3240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41142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304800" y="83820"/>
            <a:ext cx="4495800" cy="9765679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3"/>
          </a:p>
        </p:txBody>
      </p:sp>
      <p:pic>
        <p:nvPicPr>
          <p:cNvPr id="1027" name="Picture 3" descr="C:\Dropbox\UPENN - Mobile DB\Fat Data Link\Shelley Staining and L1 testing\DF vs NR N2\NileRedCorrel_QS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3026" y="5465357"/>
            <a:ext cx="3487477" cy="14856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7" name="Picture 23" descr="C:\Dropbox\UPENN - Mobile DB\Fat Data Link\Shelley Staining and L1 testing\DF vs NR Images\FinalVersionsRotated\N2-44hr_FL_worm02_pos01dfcrop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66" t="29193" r="28333" b="15183"/>
          <a:stretch/>
        </p:blipFill>
        <p:spPr bwMode="auto">
          <a:xfrm>
            <a:off x="1232112" y="3812481"/>
            <a:ext cx="1050042" cy="14020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Dropbox\UPENN - Mobile DB\Fat Data Link\Shelley Staining and L1 testing\DF vs NR Images\FinalVersionsRotated\N2-24hr_FL_worm05merge_qs=0.35.pn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98" t="35079" r="26352" b="18192"/>
          <a:stretch/>
        </p:blipFill>
        <p:spPr bwMode="auto">
          <a:xfrm>
            <a:off x="3539945" y="1709088"/>
            <a:ext cx="630611" cy="991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C:\Dropbox\UPENN - Mobile DB\Fat Data Link\Shelley Staining and L1 testing\DF vs NR Images\FinalVersionsRotated\N2-24hr_FL_worm05dfcrop.pn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095" b="18177"/>
          <a:stretch/>
        </p:blipFill>
        <p:spPr bwMode="auto">
          <a:xfrm>
            <a:off x="835709" y="1714873"/>
            <a:ext cx="1749290" cy="9913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 descr="C:\Dropbox\UPENN - Mobile DB\Fat Data Link\Shelley Staining and L1 testing\DF vs NR Images\FinalVersionsRotated\N2-04hr_FL_worm04merge_qs=0.53.pn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719" b="23257"/>
          <a:stretch/>
        </p:blipFill>
        <p:spPr bwMode="auto">
          <a:xfrm>
            <a:off x="3404348" y="460789"/>
            <a:ext cx="1033193" cy="10876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C:\Dropbox\UPENN - Mobile DB\Fat Data Link\Shelley Staining and L1 testing\DF vs NR Images\FinalVersionsRotated\N2-04hr_04_FL_worm04dfcrop.pn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681" b="23270"/>
          <a:stretch/>
        </p:blipFill>
        <p:spPr bwMode="auto">
          <a:xfrm>
            <a:off x="1324571" y="460790"/>
            <a:ext cx="1032628" cy="10876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213736" y="121922"/>
            <a:ext cx="9925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rkfiel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184396" y="121922"/>
            <a:ext cx="9685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ile Re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157450" y="121922"/>
            <a:ext cx="13147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 &amp; Q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56542" y="799214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1 (4 </a:t>
            </a:r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40084" y="195977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1 (24 </a:t>
            </a:r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4151852" y="737377"/>
            <a:ext cx="400110" cy="4401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53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4120605" y="1906458"/>
            <a:ext cx="400110" cy="48987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.3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40084" y="3112278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2 (31 </a:t>
            </a:r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33400" y="4115743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3 (44 </a:t>
            </a:r>
            <a:r>
              <a:rPr lang="en-US" sz="12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4151838" y="2954740"/>
            <a:ext cx="400110" cy="4401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2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350730" y="66372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50730" y="5077883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50730" y="6920074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8" name="Rectangle 37"/>
          <p:cNvSpPr/>
          <p:nvPr/>
        </p:nvSpPr>
        <p:spPr>
          <a:xfrm rot="5400000">
            <a:off x="1527426" y="3574996"/>
            <a:ext cx="13884" cy="4054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pic>
        <p:nvPicPr>
          <p:cNvPr id="1046" name="Picture 22" descr="C:\Dropbox\UPENN - Mobile DB\Fat Data Link\Shelley Staining and L1 testing\DF vs NR Images\FinalVersionsRotated\N2-44hr_FL_worm02_pos01merge_qs=0.13.pn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76" t="29102" r="30916" b="15292"/>
          <a:stretch/>
        </p:blipFill>
        <p:spPr bwMode="auto">
          <a:xfrm>
            <a:off x="3308325" y="3841670"/>
            <a:ext cx="885160" cy="14020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9" name="Rectangle 38"/>
          <p:cNvSpPr/>
          <p:nvPr/>
        </p:nvSpPr>
        <p:spPr>
          <a:xfrm rot="5400000">
            <a:off x="1462168" y="2578143"/>
            <a:ext cx="13884" cy="2749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40" name="Rectangle 39"/>
          <p:cNvSpPr/>
          <p:nvPr/>
        </p:nvSpPr>
        <p:spPr>
          <a:xfrm rot="5400000">
            <a:off x="1439951" y="1447077"/>
            <a:ext cx="13884" cy="2304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42" name="Rectangle 41"/>
          <p:cNvSpPr/>
          <p:nvPr/>
        </p:nvSpPr>
        <p:spPr>
          <a:xfrm rot="5400000">
            <a:off x="1501248" y="9524775"/>
            <a:ext cx="45720" cy="6026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3"/>
          </a:p>
        </p:txBody>
      </p:sp>
      <p:sp>
        <p:nvSpPr>
          <p:cNvPr id="22" name="Rectangle 21"/>
          <p:cNvSpPr/>
          <p:nvPr/>
        </p:nvSpPr>
        <p:spPr>
          <a:xfrm rot="5400000">
            <a:off x="1564441" y="5036084"/>
            <a:ext cx="13884" cy="4470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3"/>
          </a:p>
        </p:txBody>
      </p:sp>
      <p:pic>
        <p:nvPicPr>
          <p:cNvPr id="1039" name="Picture 15" descr="C:\Dropbox\UPENN - Mobile DB\Fat Data Link\Shelley Staining and L1 testing\DF vs NR Images\FinalVersionsRotated\N2-04hr_04_FL_worm04flcrop.pn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665" b="23311"/>
          <a:stretch/>
        </p:blipFill>
        <p:spPr bwMode="auto">
          <a:xfrm>
            <a:off x="2357199" y="460790"/>
            <a:ext cx="1033193" cy="10876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C:\Dropbox\UPENN - Mobile DB\Fat Data Link\Shelley Staining and L1 testing\DF vs NR Images\FinalVersionsRotated\N2-24hr_FL_worm05flcrop.pn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38" t="35085" r="31331" b="18179"/>
          <a:stretch/>
        </p:blipFill>
        <p:spPr bwMode="auto">
          <a:xfrm>
            <a:off x="2530760" y="1714873"/>
            <a:ext cx="547981" cy="991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3" name="Picture 19" descr="C:\Dropbox\UPENN - Mobile DB\Fat Data Link\Shelley Staining and L1 testing\DF vs NR Images\FinalVersionsRotated\N2-31hr_FL_worm05merge_qs=0.2.pn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4" t="17359" r="42763" b="53855"/>
          <a:stretch/>
        </p:blipFill>
        <p:spPr bwMode="auto">
          <a:xfrm>
            <a:off x="3484568" y="2843099"/>
            <a:ext cx="512004" cy="896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C:\Dropbox\UPENN - Mobile DB\Fat Data Link\Shelley Staining and L1 testing\DF vs NR Images\FinalVersionsRotated\N2-31hr_FL_worm05dfcrop.pn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23" t="16808" r="38694" b="54514"/>
          <a:stretch/>
        </p:blipFill>
        <p:spPr bwMode="auto">
          <a:xfrm>
            <a:off x="1454849" y="2843099"/>
            <a:ext cx="604570" cy="893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5" name="Picture 21" descr="C:\Dropbox\UPENN - Mobile DB\Fat Data Link\Shelley Staining and L1 testing\DF vs NR Images\FinalVersionsRotated\N2-31hr_FL_worm05flcrop.png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17" t="17110" r="21637" b="54207"/>
          <a:stretch/>
        </p:blipFill>
        <p:spPr bwMode="auto">
          <a:xfrm>
            <a:off x="2206315" y="2843099"/>
            <a:ext cx="1301705" cy="893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8" name="Picture 24" descr="C:\Dropbox\UPENN - Mobile DB\Fat Data Link\Shelley Staining and L1 testing\DF vs NR Images\FinalVersionsRotated\N2-44hr_FL_worm02_pos01flcrop.pn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99" t="29093" r="27241" b="15302"/>
          <a:stretch/>
        </p:blipFill>
        <p:spPr bwMode="auto">
          <a:xfrm>
            <a:off x="2305764" y="3812481"/>
            <a:ext cx="997974" cy="14020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/>
          <p:cNvSpPr txBox="1"/>
          <p:nvPr/>
        </p:nvSpPr>
        <p:spPr>
          <a:xfrm rot="16200000">
            <a:off x="4151838" y="4176346"/>
            <a:ext cx="400110" cy="4401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13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371600" y="7086600"/>
            <a:ext cx="8915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rkfield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407814" y="7086600"/>
            <a:ext cx="8723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ile Red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83"/>
          <a:stretch/>
        </p:blipFill>
        <p:spPr>
          <a:xfrm>
            <a:off x="3508020" y="7380074"/>
            <a:ext cx="877578" cy="240381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4602" y="7358081"/>
            <a:ext cx="1081862" cy="24038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6463" y="7358080"/>
            <a:ext cx="1081862" cy="2403815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3564584" y="7086600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lay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3610685" y="7942374"/>
            <a:ext cx="301302" cy="254556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>
            <a:off x="2541867" y="7942374"/>
            <a:ext cx="301302" cy="254556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>
            <a:off x="1454684" y="7928761"/>
            <a:ext cx="301302" cy="254556"/>
          </a:xfrm>
          <a:prstGeom prst="straightConnector1">
            <a:avLst/>
          </a:prstGeom>
          <a:ln w="762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3583231" y="7558498"/>
            <a:ext cx="301302" cy="254556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2514414" y="7558498"/>
            <a:ext cx="301302" cy="254556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1427230" y="7544885"/>
            <a:ext cx="301302" cy="254556"/>
          </a:xfrm>
          <a:prstGeom prst="straightConnector1">
            <a:avLst/>
          </a:prstGeom>
          <a:ln w="762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65791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2538" y="1028916"/>
            <a:ext cx="4511192" cy="6177850"/>
          </a:xfrm>
          <a:prstGeom prst="rect">
            <a:avLst/>
          </a:prstGeom>
        </p:spPr>
      </p:pic>
      <p:sp>
        <p:nvSpPr>
          <p:cNvPr id="3" name="Text Box 21"/>
          <p:cNvSpPr txBox="1"/>
          <p:nvPr/>
        </p:nvSpPr>
        <p:spPr>
          <a:xfrm>
            <a:off x="1203960" y="502920"/>
            <a:ext cx="662866" cy="555374"/>
          </a:xfrm>
          <a:prstGeom prst="rect">
            <a:avLst/>
          </a:prstGeom>
          <a:solidFill>
            <a:schemeClr val="lt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550"/>
              </a:spcAft>
            </a:pPr>
            <a:r>
              <a:rPr lang="en-US" sz="2640" b="1" dirty="0">
                <a:latin typeface="Arial"/>
                <a:ea typeface="Calibri"/>
                <a:cs typeface="Times New Roman"/>
              </a:rPr>
              <a:t>A</a:t>
            </a:r>
            <a:endParaRPr lang="en-US" sz="1760" dirty="0">
              <a:ea typeface="Calibri"/>
              <a:cs typeface="Times New Roman"/>
            </a:endParaRPr>
          </a:p>
        </p:txBody>
      </p:sp>
      <p:sp>
        <p:nvSpPr>
          <p:cNvPr id="4" name="Text Box 31"/>
          <p:cNvSpPr txBox="1"/>
          <p:nvPr/>
        </p:nvSpPr>
        <p:spPr>
          <a:xfrm>
            <a:off x="1203960" y="3688080"/>
            <a:ext cx="662866" cy="555374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550"/>
              </a:spcAft>
            </a:pPr>
            <a:r>
              <a:rPr lang="en-US" sz="2640" b="1" dirty="0">
                <a:latin typeface="Arial"/>
                <a:ea typeface="Calibri"/>
                <a:cs typeface="Times New Roman"/>
              </a:rPr>
              <a:t>B</a:t>
            </a:r>
            <a:endParaRPr lang="en-US" sz="1760" dirty="0">
              <a:ea typeface="Calibri"/>
              <a:cs typeface="Times New Roman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 flipV="1">
            <a:off x="3798134" y="4330550"/>
            <a:ext cx="0" cy="2209551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V="1">
            <a:off x="4764564" y="4330550"/>
            <a:ext cx="0" cy="2209551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 Box 28"/>
          <p:cNvSpPr txBox="1"/>
          <p:nvPr/>
        </p:nvSpPr>
        <p:spPr>
          <a:xfrm>
            <a:off x="3135268" y="4329555"/>
            <a:ext cx="662866" cy="555374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550"/>
              </a:spcAft>
            </a:pPr>
            <a:r>
              <a:rPr lang="en-US" sz="1400" b="1">
                <a:latin typeface="Arial"/>
                <a:ea typeface="Calibri"/>
                <a:cs typeface="Times New Roman"/>
              </a:rPr>
              <a:t>L1</a:t>
            </a:r>
            <a:endParaRPr lang="en-US" sz="2000">
              <a:ea typeface="Calibri"/>
              <a:cs typeface="Times New Roman"/>
            </a:endParaRPr>
          </a:p>
        </p:txBody>
      </p:sp>
      <p:sp>
        <p:nvSpPr>
          <p:cNvPr id="8" name="Text Box 30"/>
          <p:cNvSpPr txBox="1"/>
          <p:nvPr/>
        </p:nvSpPr>
        <p:spPr>
          <a:xfrm>
            <a:off x="3967334" y="4329555"/>
            <a:ext cx="662866" cy="555374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550"/>
              </a:spcAft>
            </a:pPr>
            <a:r>
              <a:rPr lang="en-US" sz="1400" b="1">
                <a:latin typeface="Arial"/>
                <a:ea typeface="Calibri"/>
                <a:cs typeface="Times New Roman"/>
              </a:rPr>
              <a:t>L2</a:t>
            </a:r>
            <a:endParaRPr lang="en-US" sz="2000">
              <a:ea typeface="Calibri"/>
              <a:cs typeface="Times New Roman"/>
            </a:endParaRPr>
          </a:p>
        </p:txBody>
      </p:sp>
      <p:sp>
        <p:nvSpPr>
          <p:cNvPr id="9" name="Text Box 33"/>
          <p:cNvSpPr txBox="1"/>
          <p:nvPr/>
        </p:nvSpPr>
        <p:spPr>
          <a:xfrm>
            <a:off x="5071114" y="4330550"/>
            <a:ext cx="662866" cy="555374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550"/>
              </a:spcAft>
            </a:pPr>
            <a:r>
              <a:rPr lang="en-US" sz="1400" b="1" dirty="0">
                <a:latin typeface="Arial"/>
                <a:ea typeface="Calibri"/>
                <a:cs typeface="Times New Roman"/>
              </a:rPr>
              <a:t>L3</a:t>
            </a:r>
            <a:endParaRPr lang="en-US" sz="2000" dirty="0">
              <a:ea typeface="Calibri"/>
              <a:cs typeface="Times New Roman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 flipV="1">
            <a:off x="3798134" y="1286419"/>
            <a:ext cx="0" cy="2209551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V="1">
            <a:off x="4764564" y="1286419"/>
            <a:ext cx="0" cy="2209551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 Box 38"/>
          <p:cNvSpPr txBox="1"/>
          <p:nvPr/>
        </p:nvSpPr>
        <p:spPr>
          <a:xfrm>
            <a:off x="3135268" y="1295901"/>
            <a:ext cx="662866" cy="555374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550"/>
              </a:spcAft>
            </a:pPr>
            <a:r>
              <a:rPr lang="en-US" sz="1400" b="1" dirty="0">
                <a:latin typeface="Arial"/>
                <a:ea typeface="Calibri"/>
                <a:cs typeface="Times New Roman"/>
              </a:rPr>
              <a:t>L1</a:t>
            </a:r>
            <a:endParaRPr lang="en-US" sz="2000" dirty="0">
              <a:ea typeface="Calibri"/>
              <a:cs typeface="Times New Roman"/>
            </a:endParaRPr>
          </a:p>
        </p:txBody>
      </p:sp>
      <p:sp>
        <p:nvSpPr>
          <p:cNvPr id="13" name="Text Box 39"/>
          <p:cNvSpPr txBox="1"/>
          <p:nvPr/>
        </p:nvSpPr>
        <p:spPr>
          <a:xfrm>
            <a:off x="3967334" y="1295901"/>
            <a:ext cx="662866" cy="555374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550"/>
              </a:spcAft>
            </a:pPr>
            <a:r>
              <a:rPr lang="en-US" sz="1400" b="1">
                <a:latin typeface="Arial"/>
                <a:ea typeface="Calibri"/>
                <a:cs typeface="Times New Roman"/>
              </a:rPr>
              <a:t>L2</a:t>
            </a:r>
            <a:endParaRPr lang="en-US" sz="2000">
              <a:ea typeface="Calibri"/>
              <a:cs typeface="Times New Roman"/>
            </a:endParaRPr>
          </a:p>
        </p:txBody>
      </p:sp>
      <p:sp>
        <p:nvSpPr>
          <p:cNvPr id="14" name="Text Box 40"/>
          <p:cNvSpPr txBox="1"/>
          <p:nvPr/>
        </p:nvSpPr>
        <p:spPr>
          <a:xfrm>
            <a:off x="5071114" y="1290925"/>
            <a:ext cx="662866" cy="555374"/>
          </a:xfrm>
          <a:prstGeom prst="rect">
            <a:avLst/>
          </a:prstGeom>
          <a:noFill/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50292" tIns="25146" rIns="50292" bIns="25146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550"/>
              </a:spcAft>
            </a:pPr>
            <a:r>
              <a:rPr lang="en-US" sz="1400" b="1">
                <a:latin typeface="Arial"/>
                <a:ea typeface="Calibri"/>
                <a:cs typeface="Times New Roman"/>
              </a:rPr>
              <a:t>L3</a:t>
            </a:r>
            <a:endParaRPr lang="en-US" sz="200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909255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22</TotalTime>
  <Words>104</Words>
  <Application>Microsoft Macintosh PowerPoint</Application>
  <PresentationFormat>Custom</PresentationFormat>
  <Paragraphs>81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2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</dc:creator>
  <cp:lastModifiedBy>Christopher Fang-Yen</cp:lastModifiedBy>
  <cp:revision>269</cp:revision>
  <cp:lastPrinted>2017-04-06T01:44:44Z</cp:lastPrinted>
  <dcterms:created xsi:type="dcterms:W3CDTF">2006-08-16T00:00:00Z</dcterms:created>
  <dcterms:modified xsi:type="dcterms:W3CDTF">2017-04-06T22:21:16Z</dcterms:modified>
</cp:coreProperties>
</file>